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4" saveSubsetFonts="1">
  <p:sldMasterIdLst>
    <p:sldMasterId id="2147483648" r:id="rId1"/>
  </p:sldMasterIdLst>
  <p:notesMasterIdLst>
    <p:notesMasterId r:id="rId8"/>
  </p:notesMasterIdLst>
  <p:sldIdLst>
    <p:sldId id="260" r:id="rId2"/>
    <p:sldId id="258" r:id="rId3"/>
    <p:sldId id="257" r:id="rId4"/>
    <p:sldId id="261" r:id="rId5"/>
    <p:sldId id="256" r:id="rId6"/>
    <p:sldId id="259" r:id="rId7"/>
  </p:sldIdLst>
  <p:sldSz cx="9906000" cy="6858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0" autoAdjust="0"/>
    <p:restoredTop sz="94424" autoAdjust="0"/>
  </p:normalViewPr>
  <p:slideViewPr>
    <p:cSldViewPr>
      <p:cViewPr varScale="1">
        <p:scale>
          <a:sx n="86" d="100"/>
          <a:sy n="86" d="100"/>
        </p:scale>
        <p:origin x="1656" y="91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DB8204-EBCD-4235-8D31-4FCFD50CCDCA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952500" y="685800"/>
            <a:ext cx="4953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0F96388-94F5-4685-B1D9-B23CCDFE8B0C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256338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952500" y="685800"/>
            <a:ext cx="4953000" cy="34290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F96388-94F5-4685-B1D9-B23CCDFE8B0C}" type="slidenum">
              <a:rPr lang="zh-CN" altLang="en-US" smtClean="0"/>
              <a:t>8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96768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742950" y="2130428"/>
            <a:ext cx="84201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31650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63301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949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2660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15825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189903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21554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253205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7181850" y="274641"/>
            <a:ext cx="222885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95300" y="274641"/>
            <a:ext cx="652145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2769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82506" y="2906715"/>
            <a:ext cx="8420100" cy="1500187"/>
          </a:xfrm>
        </p:spPr>
        <p:txBody>
          <a:bodyPr anchor="b"/>
          <a:lstStyle>
            <a:lvl1pPr marL="0" indent="0">
              <a:buNone/>
              <a:defRPr sz="1385">
                <a:solidFill>
                  <a:schemeClr val="tx1">
                    <a:tint val="75000"/>
                  </a:schemeClr>
                </a:solidFill>
              </a:defRPr>
            </a:lvl1pPr>
            <a:lvl2pPr marL="316506" indent="0">
              <a:buNone/>
              <a:defRPr sz="1246">
                <a:solidFill>
                  <a:schemeClr val="tx1">
                    <a:tint val="75000"/>
                  </a:schemeClr>
                </a:solidFill>
              </a:defRPr>
            </a:lvl2pPr>
            <a:lvl3pPr marL="633012" indent="0">
              <a:buNone/>
              <a:defRPr sz="1108">
                <a:solidFill>
                  <a:schemeClr val="tx1">
                    <a:tint val="75000"/>
                  </a:schemeClr>
                </a:solidFill>
              </a:defRPr>
            </a:lvl3pPr>
            <a:lvl4pPr marL="949519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4pPr>
            <a:lvl5pPr marL="1266026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5pPr>
            <a:lvl6pPr marL="1582531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6pPr>
            <a:lvl7pPr marL="1899038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7pPr>
            <a:lvl8pPr marL="2215544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8pPr>
            <a:lvl9pPr marL="2532051" indent="0">
              <a:buNone/>
              <a:defRPr sz="969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1938"/>
            </a:lvl1pPr>
            <a:lvl2pPr>
              <a:defRPr sz="1662"/>
            </a:lvl2pPr>
            <a:lvl3pPr>
              <a:defRPr sz="1385"/>
            </a:lvl3pPr>
            <a:lvl4pPr>
              <a:defRPr sz="1246"/>
            </a:lvl4pPr>
            <a:lvl5pPr>
              <a:defRPr sz="1246"/>
            </a:lvl5pPr>
            <a:lvl6pPr>
              <a:defRPr sz="1246"/>
            </a:lvl6pPr>
            <a:lvl7pPr>
              <a:defRPr sz="1246"/>
            </a:lvl7pPr>
            <a:lvl8pPr>
              <a:defRPr sz="1246"/>
            </a:lvl8pPr>
            <a:lvl9pPr>
              <a:defRPr sz="1246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1938"/>
            </a:lvl1pPr>
            <a:lvl2pPr>
              <a:defRPr sz="1662"/>
            </a:lvl2pPr>
            <a:lvl3pPr>
              <a:defRPr sz="1385"/>
            </a:lvl3pPr>
            <a:lvl4pPr>
              <a:defRPr sz="1246"/>
            </a:lvl4pPr>
            <a:lvl5pPr>
              <a:defRPr sz="1246"/>
            </a:lvl5pPr>
            <a:lvl6pPr>
              <a:defRPr sz="1246"/>
            </a:lvl6pPr>
            <a:lvl7pPr>
              <a:defRPr sz="1246"/>
            </a:lvl7pPr>
            <a:lvl8pPr>
              <a:defRPr sz="1246"/>
            </a:lvl8pPr>
            <a:lvl9pPr>
              <a:defRPr sz="1246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95302" y="1535113"/>
            <a:ext cx="4376870" cy="639762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06" indent="0">
              <a:buNone/>
              <a:defRPr sz="1385" b="1"/>
            </a:lvl2pPr>
            <a:lvl3pPr marL="633012" indent="0">
              <a:buNone/>
              <a:defRPr sz="1246" b="1"/>
            </a:lvl3pPr>
            <a:lvl4pPr marL="949519" indent="0">
              <a:buNone/>
              <a:defRPr sz="1108" b="1"/>
            </a:lvl4pPr>
            <a:lvl5pPr marL="1266026" indent="0">
              <a:buNone/>
              <a:defRPr sz="1108" b="1"/>
            </a:lvl5pPr>
            <a:lvl6pPr marL="1582531" indent="0">
              <a:buNone/>
              <a:defRPr sz="1108" b="1"/>
            </a:lvl6pPr>
            <a:lvl7pPr marL="1899038" indent="0">
              <a:buNone/>
              <a:defRPr sz="1108" b="1"/>
            </a:lvl7pPr>
            <a:lvl8pPr marL="2215544" indent="0">
              <a:buNone/>
              <a:defRPr sz="1108" b="1"/>
            </a:lvl8pPr>
            <a:lvl9pPr marL="2532051" indent="0">
              <a:buNone/>
              <a:defRPr sz="110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95302" y="2174875"/>
            <a:ext cx="4376870" cy="3951288"/>
          </a:xfrm>
        </p:spPr>
        <p:txBody>
          <a:bodyPr/>
          <a:lstStyle>
            <a:lvl1pPr>
              <a:defRPr sz="1662"/>
            </a:lvl1pPr>
            <a:lvl2pPr>
              <a:defRPr sz="1385"/>
            </a:lvl2pPr>
            <a:lvl3pPr>
              <a:defRPr sz="1246"/>
            </a:lvl3pPr>
            <a:lvl4pPr>
              <a:defRPr sz="1108"/>
            </a:lvl4pPr>
            <a:lvl5pPr>
              <a:defRPr sz="1108"/>
            </a:lvl5pPr>
            <a:lvl6pPr>
              <a:defRPr sz="1108"/>
            </a:lvl6pPr>
            <a:lvl7pPr>
              <a:defRPr sz="1108"/>
            </a:lvl7pPr>
            <a:lvl8pPr>
              <a:defRPr sz="1108"/>
            </a:lvl8pPr>
            <a:lvl9pPr>
              <a:defRPr sz="110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5032112" y="1535113"/>
            <a:ext cx="4378591" cy="639762"/>
          </a:xfrm>
        </p:spPr>
        <p:txBody>
          <a:bodyPr anchor="b"/>
          <a:lstStyle>
            <a:lvl1pPr marL="0" indent="0">
              <a:buNone/>
              <a:defRPr sz="1662" b="1"/>
            </a:lvl1pPr>
            <a:lvl2pPr marL="316506" indent="0">
              <a:buNone/>
              <a:defRPr sz="1385" b="1"/>
            </a:lvl2pPr>
            <a:lvl3pPr marL="633012" indent="0">
              <a:buNone/>
              <a:defRPr sz="1246" b="1"/>
            </a:lvl3pPr>
            <a:lvl4pPr marL="949519" indent="0">
              <a:buNone/>
              <a:defRPr sz="1108" b="1"/>
            </a:lvl4pPr>
            <a:lvl5pPr marL="1266026" indent="0">
              <a:buNone/>
              <a:defRPr sz="1108" b="1"/>
            </a:lvl5pPr>
            <a:lvl6pPr marL="1582531" indent="0">
              <a:buNone/>
              <a:defRPr sz="1108" b="1"/>
            </a:lvl6pPr>
            <a:lvl7pPr marL="1899038" indent="0">
              <a:buNone/>
              <a:defRPr sz="1108" b="1"/>
            </a:lvl7pPr>
            <a:lvl8pPr marL="2215544" indent="0">
              <a:buNone/>
              <a:defRPr sz="1108" b="1"/>
            </a:lvl8pPr>
            <a:lvl9pPr marL="2532051" indent="0">
              <a:buNone/>
              <a:defRPr sz="1108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5032112" y="2174875"/>
            <a:ext cx="4378591" cy="3951288"/>
          </a:xfrm>
        </p:spPr>
        <p:txBody>
          <a:bodyPr/>
          <a:lstStyle>
            <a:lvl1pPr>
              <a:defRPr sz="1662"/>
            </a:lvl1pPr>
            <a:lvl2pPr>
              <a:defRPr sz="1385"/>
            </a:lvl2pPr>
            <a:lvl3pPr>
              <a:defRPr sz="1246"/>
            </a:lvl3pPr>
            <a:lvl4pPr>
              <a:defRPr sz="1108"/>
            </a:lvl4pPr>
            <a:lvl5pPr>
              <a:defRPr sz="1108"/>
            </a:lvl5pPr>
            <a:lvl6pPr>
              <a:defRPr sz="1108"/>
            </a:lvl6pPr>
            <a:lvl7pPr>
              <a:defRPr sz="1108"/>
            </a:lvl7pPr>
            <a:lvl8pPr>
              <a:defRPr sz="1108"/>
            </a:lvl8pPr>
            <a:lvl9pPr>
              <a:defRPr sz="1108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95302" y="273050"/>
            <a:ext cx="3259006" cy="1162050"/>
          </a:xfrm>
        </p:spPr>
        <p:txBody>
          <a:bodyPr anchor="b"/>
          <a:lstStyle>
            <a:lvl1pPr algn="l">
              <a:defRPr sz="1385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72972" y="273053"/>
            <a:ext cx="5537728" cy="5853113"/>
          </a:xfrm>
        </p:spPr>
        <p:txBody>
          <a:bodyPr/>
          <a:lstStyle>
            <a:lvl1pPr>
              <a:defRPr sz="2215"/>
            </a:lvl1pPr>
            <a:lvl2pPr>
              <a:defRPr sz="1938"/>
            </a:lvl2pPr>
            <a:lvl3pPr>
              <a:defRPr sz="1662"/>
            </a:lvl3pPr>
            <a:lvl4pPr>
              <a:defRPr sz="1385"/>
            </a:lvl4pPr>
            <a:lvl5pPr>
              <a:defRPr sz="1385"/>
            </a:lvl5pPr>
            <a:lvl6pPr>
              <a:defRPr sz="1385"/>
            </a:lvl6pPr>
            <a:lvl7pPr>
              <a:defRPr sz="1385"/>
            </a:lvl7pPr>
            <a:lvl8pPr>
              <a:defRPr sz="1385"/>
            </a:lvl8pPr>
            <a:lvl9pPr>
              <a:defRPr sz="138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95302" y="1435101"/>
            <a:ext cx="3259006" cy="4691063"/>
          </a:xfrm>
        </p:spPr>
        <p:txBody>
          <a:bodyPr/>
          <a:lstStyle>
            <a:lvl1pPr marL="0" indent="0">
              <a:buNone/>
              <a:defRPr sz="969"/>
            </a:lvl1pPr>
            <a:lvl2pPr marL="316506" indent="0">
              <a:buNone/>
              <a:defRPr sz="831"/>
            </a:lvl2pPr>
            <a:lvl3pPr marL="633012" indent="0">
              <a:buNone/>
              <a:defRPr sz="692"/>
            </a:lvl3pPr>
            <a:lvl4pPr marL="949519" indent="0">
              <a:buNone/>
              <a:defRPr sz="623"/>
            </a:lvl4pPr>
            <a:lvl5pPr marL="1266026" indent="0">
              <a:buNone/>
              <a:defRPr sz="623"/>
            </a:lvl5pPr>
            <a:lvl6pPr marL="1582531" indent="0">
              <a:buNone/>
              <a:defRPr sz="623"/>
            </a:lvl6pPr>
            <a:lvl7pPr marL="1899038" indent="0">
              <a:buNone/>
              <a:defRPr sz="623"/>
            </a:lvl7pPr>
            <a:lvl8pPr marL="2215544" indent="0">
              <a:buNone/>
              <a:defRPr sz="623"/>
            </a:lvl8pPr>
            <a:lvl9pPr marL="2532051" indent="0">
              <a:buNone/>
              <a:defRPr sz="62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1385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2215"/>
            </a:lvl1pPr>
            <a:lvl2pPr marL="316506" indent="0">
              <a:buNone/>
              <a:defRPr sz="1938"/>
            </a:lvl2pPr>
            <a:lvl3pPr marL="633012" indent="0">
              <a:buNone/>
              <a:defRPr sz="1662"/>
            </a:lvl3pPr>
            <a:lvl4pPr marL="949519" indent="0">
              <a:buNone/>
              <a:defRPr sz="1385"/>
            </a:lvl4pPr>
            <a:lvl5pPr marL="1266026" indent="0">
              <a:buNone/>
              <a:defRPr sz="1385"/>
            </a:lvl5pPr>
            <a:lvl6pPr marL="1582531" indent="0">
              <a:buNone/>
              <a:defRPr sz="1385"/>
            </a:lvl6pPr>
            <a:lvl7pPr marL="1899038" indent="0">
              <a:buNone/>
              <a:defRPr sz="1385"/>
            </a:lvl7pPr>
            <a:lvl8pPr marL="2215544" indent="0">
              <a:buNone/>
              <a:defRPr sz="1385"/>
            </a:lvl8pPr>
            <a:lvl9pPr marL="2532051" indent="0">
              <a:buNone/>
              <a:defRPr sz="1385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969"/>
            </a:lvl1pPr>
            <a:lvl2pPr marL="316506" indent="0">
              <a:buNone/>
              <a:defRPr sz="831"/>
            </a:lvl2pPr>
            <a:lvl3pPr marL="633012" indent="0">
              <a:buNone/>
              <a:defRPr sz="692"/>
            </a:lvl3pPr>
            <a:lvl4pPr marL="949519" indent="0">
              <a:buNone/>
              <a:defRPr sz="623"/>
            </a:lvl4pPr>
            <a:lvl5pPr marL="1266026" indent="0">
              <a:buNone/>
              <a:defRPr sz="623"/>
            </a:lvl5pPr>
            <a:lvl6pPr marL="1582531" indent="0">
              <a:buNone/>
              <a:defRPr sz="623"/>
            </a:lvl6pPr>
            <a:lvl7pPr marL="1899038" indent="0">
              <a:buNone/>
              <a:defRPr sz="623"/>
            </a:lvl7pPr>
            <a:lvl8pPr marL="2215544" indent="0">
              <a:buNone/>
              <a:defRPr sz="623"/>
            </a:lvl8pPr>
            <a:lvl9pPr marL="2532051" indent="0">
              <a:buNone/>
              <a:defRPr sz="62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95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1/9/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384550" y="6356353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7099300" y="6356353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831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33012" rtl="0" eaLnBrk="1" latinLnBrk="0" hangingPunct="1">
        <a:spcBef>
          <a:spcPct val="0"/>
        </a:spcBef>
        <a:buNone/>
        <a:defRPr sz="304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7380" indent="-237380" algn="l" defTabSz="633012" rtl="0" eaLnBrk="1" latinLnBrk="0" hangingPunct="1">
        <a:spcBef>
          <a:spcPct val="20000"/>
        </a:spcBef>
        <a:buFont typeface="Arial" pitchFamily="34" charset="0"/>
        <a:buChar char="•"/>
        <a:defRPr sz="2215" kern="1200">
          <a:solidFill>
            <a:schemeClr val="tx1"/>
          </a:solidFill>
          <a:latin typeface="+mn-lt"/>
          <a:ea typeface="+mn-ea"/>
          <a:cs typeface="+mn-cs"/>
        </a:defRPr>
      </a:lvl1pPr>
      <a:lvl2pPr marL="514323" indent="-197816" algn="l" defTabSz="633012" rtl="0" eaLnBrk="1" latinLnBrk="0" hangingPunct="1">
        <a:spcBef>
          <a:spcPct val="20000"/>
        </a:spcBef>
        <a:buFont typeface="Arial" pitchFamily="34" charset="0"/>
        <a:buChar char="–"/>
        <a:defRPr sz="1938" kern="1200">
          <a:solidFill>
            <a:schemeClr val="tx1"/>
          </a:solidFill>
          <a:latin typeface="+mn-lt"/>
          <a:ea typeface="+mn-ea"/>
          <a:cs typeface="+mn-cs"/>
        </a:defRPr>
      </a:lvl2pPr>
      <a:lvl3pPr marL="791266" indent="-158254" algn="l" defTabSz="633012" rtl="0" eaLnBrk="1" latinLnBrk="0" hangingPunct="1">
        <a:spcBef>
          <a:spcPct val="20000"/>
        </a:spcBef>
        <a:buFont typeface="Arial" pitchFamily="34" charset="0"/>
        <a:buChar char="•"/>
        <a:defRPr sz="1662" kern="1200">
          <a:solidFill>
            <a:schemeClr val="tx1"/>
          </a:solidFill>
          <a:latin typeface="+mn-lt"/>
          <a:ea typeface="+mn-ea"/>
          <a:cs typeface="+mn-cs"/>
        </a:defRPr>
      </a:lvl3pPr>
      <a:lvl4pPr marL="1107772" indent="-158254" algn="l" defTabSz="633012" rtl="0" eaLnBrk="1" latinLnBrk="0" hangingPunct="1">
        <a:spcBef>
          <a:spcPct val="20000"/>
        </a:spcBef>
        <a:buFont typeface="Arial" pitchFamily="34" charset="0"/>
        <a:buChar char="–"/>
        <a:defRPr sz="1385" kern="1200">
          <a:solidFill>
            <a:schemeClr val="tx1"/>
          </a:solidFill>
          <a:latin typeface="+mn-lt"/>
          <a:ea typeface="+mn-ea"/>
          <a:cs typeface="+mn-cs"/>
        </a:defRPr>
      </a:lvl4pPr>
      <a:lvl5pPr marL="1424278" indent="-158254" algn="l" defTabSz="633012" rtl="0" eaLnBrk="1" latinLnBrk="0" hangingPunct="1">
        <a:spcBef>
          <a:spcPct val="20000"/>
        </a:spcBef>
        <a:buFont typeface="Arial" pitchFamily="34" charset="0"/>
        <a:buChar char="»"/>
        <a:defRPr sz="1385" kern="1200">
          <a:solidFill>
            <a:schemeClr val="tx1"/>
          </a:solidFill>
          <a:latin typeface="+mn-lt"/>
          <a:ea typeface="+mn-ea"/>
          <a:cs typeface="+mn-cs"/>
        </a:defRPr>
      </a:lvl5pPr>
      <a:lvl6pPr marL="1740785" indent="-158254" algn="l" defTabSz="633012" rtl="0" eaLnBrk="1" latinLnBrk="0" hangingPunct="1">
        <a:spcBef>
          <a:spcPct val="20000"/>
        </a:spcBef>
        <a:buFont typeface="Arial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6pPr>
      <a:lvl7pPr marL="2057291" indent="-158254" algn="l" defTabSz="633012" rtl="0" eaLnBrk="1" latinLnBrk="0" hangingPunct="1">
        <a:spcBef>
          <a:spcPct val="20000"/>
        </a:spcBef>
        <a:buFont typeface="Arial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7pPr>
      <a:lvl8pPr marL="2373798" indent="-158254" algn="l" defTabSz="633012" rtl="0" eaLnBrk="1" latinLnBrk="0" hangingPunct="1">
        <a:spcBef>
          <a:spcPct val="20000"/>
        </a:spcBef>
        <a:buFont typeface="Arial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8pPr>
      <a:lvl9pPr marL="2690303" indent="-158254" algn="l" defTabSz="633012" rtl="0" eaLnBrk="1" latinLnBrk="0" hangingPunct="1">
        <a:spcBef>
          <a:spcPct val="20000"/>
        </a:spcBef>
        <a:buFont typeface="Arial" pitchFamily="34" charset="0"/>
        <a:buChar char="•"/>
        <a:defRPr sz="138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33012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1pPr>
      <a:lvl2pPr marL="316506" algn="l" defTabSz="633012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2pPr>
      <a:lvl3pPr marL="633012" algn="l" defTabSz="633012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3pPr>
      <a:lvl4pPr marL="949519" algn="l" defTabSz="633012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4pPr>
      <a:lvl5pPr marL="1266026" algn="l" defTabSz="633012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5pPr>
      <a:lvl6pPr marL="1582531" algn="l" defTabSz="633012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6pPr>
      <a:lvl7pPr marL="1899038" algn="l" defTabSz="633012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7pPr>
      <a:lvl8pPr marL="2215544" algn="l" defTabSz="633012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8pPr>
      <a:lvl9pPr marL="2532051" algn="l" defTabSz="633012" rtl="0" eaLnBrk="1" latinLnBrk="0" hangingPunct="1">
        <a:defRPr sz="1246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"/>
          <p:cNvSpPr txBox="1"/>
          <p:nvPr/>
        </p:nvSpPr>
        <p:spPr>
          <a:xfrm>
            <a:off x="4808984" y="548680"/>
            <a:ext cx="4763877" cy="35548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. Effects of </a:t>
            </a:r>
            <a:r>
              <a:rPr lang="en-US" altLang="zh-CN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g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Leu on the location of mTOR on LAMP2-positive lysosomal clusters in C2C12 cell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</a:p>
          <a:p>
            <a:pPr algn="just">
              <a:lnSpc>
                <a:spcPct val="150000"/>
              </a:lnSpc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 C2C12 cells were pretreatment without serum for 15 h and without amino acids for 3 h, then cultured for 10 min in a special medium (Supplemental Table 1) including the no amino acids group (–AA), the only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g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roup (+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rg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, the only Leu group (+Leu). Cells were stained with anti-mTOR (2983, Cell Signaling) or anti-LAMP2. Scale bar: 10µM. (B) Ratio of mTOR to LAMP2 (%). To assess mTOR translocation, the numbers of mTOR and LAMP2-positive spots per cell were calculated using IPP6.0 and Image J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ftware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ues are the mean ± SEM; n = 3; *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88504" y="4431"/>
            <a:ext cx="4166617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839902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3"/>
          <p:cNvSpPr txBox="1"/>
          <p:nvPr/>
        </p:nvSpPr>
        <p:spPr>
          <a:xfrm>
            <a:off x="5509073" y="0"/>
            <a:ext cx="4250216" cy="609397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2. Glutamine (Gln) increases </a:t>
            </a:r>
            <a:r>
              <a:rPr lang="en-US" altLang="zh-CN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OR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S6K1 phosphorylation and has no effect on the mRNA and protein levels of SLC38A9 and SLC36A1.</a:t>
            </a:r>
          </a:p>
          <a:p>
            <a:pPr algn="just">
              <a:lnSpc>
                <a:spcPct val="150000"/>
              </a:lnSpc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2C12 cells were pretreatment without serum for 15 h and without amino acids for 3 h, then incubated for 10 min in Gln medium (Supplemental Table 1). Immunoblotting analysis of protein samples with anti-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O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ti-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O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anti-S6K, anti-phospho-S6K, anti-SLC38A9, anti-SLC36A1, or anti-</a:t>
            </a:r>
            <a:r>
              <a:rPr lang="el-GR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β-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n antibody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TO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to β-Actin loading control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-mTOR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relative to β-Actin loading control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p70S6K relative to β-Actin loading control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 p70S6K relative to β-Actin loading control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LC38A9 relative to β-Actin loading control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LC36A1 relative to β-Actin loading control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mRNA level of SLC38A9 or SLC36A1 was analyzed by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Values are the mean ± SEM; n = 3; *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5638044" cy="6858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42784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"/>
          <p:cNvSpPr txBox="1"/>
          <p:nvPr/>
        </p:nvSpPr>
        <p:spPr>
          <a:xfrm>
            <a:off x="5601072" y="260648"/>
            <a:ext cx="4160912" cy="60478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3. Inhibition of SLC38A9 or SLC36A1 suppressed the mRNA and protein levels of SLC36A1 and SLC38A9 in different cell lines. </a:t>
            </a:r>
          </a:p>
          <a:p>
            <a:pPr algn="just">
              <a:lnSpc>
                <a:spcPct val="150000"/>
              </a:lnSpc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dividual siRNAs was transfected to knockdown SLC38A9 in different cell lines (3T3-L1, BHK-21, PK-15 and ST), and the mRNA level of SLC36A1 was analyzed by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mmunoblotting analysis of protein samples from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ith anti-SLC38A9, anti-SLC36A1, or anti-β-Actin antibody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LC38A9 relative to β-Actin loading control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LC36A1 relative to β-Actin loading control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dividual siRNAs was transfected to knockdown SLC36A1 in different cell lines (3T3-L1, BHK-21, PK-15 and ST), and the mRNA level of SLC38A9 was analyzed by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qRT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PCR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mmunoblotting analysis of protein samples from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E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with anti-SLC36A1, anti-SLC38A9, or anti-β-Actin antibody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LC36A1 relative to β-Actin loading control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ensitometri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detection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of SLC38A9 relative to β-Actin loading control. Values are the mean ± SEM; n = 3; *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.</a:t>
            </a:r>
          </a:p>
          <a:p>
            <a:pPr algn="just">
              <a:lnSpc>
                <a:spcPct val="150000"/>
              </a:lnSpc>
            </a:pPr>
            <a:endParaRPr lang="zh-CN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576" y="0"/>
            <a:ext cx="5449504" cy="684250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96011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"/>
          <p:cNvSpPr txBox="1"/>
          <p:nvPr/>
        </p:nvSpPr>
        <p:spPr>
          <a:xfrm>
            <a:off x="5695746" y="332493"/>
            <a:ext cx="4160912" cy="49859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4. Effects of overexpression or inhibition of SLC38A9 and SLC36A1 on the location of SLC38A9 or SLC36A1 on LAMP2-positive lysosomal clusters. </a:t>
            </a:r>
          </a:p>
          <a:p>
            <a:pPr algn="just">
              <a:lnSpc>
                <a:spcPct val="150000"/>
              </a:lnSpc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2C12 cells were transfected with pcDNA3.1-SLC38A9 construct or siRNA to overexpress or knockdown SLC38A9, and stained with anti-SLC38A9 or anti-LAMP2. Scale bar: 10µM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atio of SLC38A9 to LAMP2 (%)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2C12 cells were transfected with pcDNA3.1-SLC36A1 construct or siRNA to overexpress or knockdown SLC36A1, and stained with anti-SLC36A1 or anti-LAMP2. Scale bar: 10µM. 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Ratio of SLC36A1 to LAMP2 (%). To assess SLC38A9 or SLC36A1 translocation, the numbers of SLC38A9, SLC36A1 and LAMP2-positive spots per cell were calculated using IPP6.0 and Image J </a:t>
            </a:r>
            <a:r>
              <a:rPr lang="en-US" altLang="zh-CN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oftwares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Values are the mean ± SEM; n = 3; * 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5; **</a:t>
            </a:r>
            <a:r>
              <a:rPr lang="en-US" altLang="zh-CN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p 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&lt; 0.01.</a:t>
            </a:r>
          </a:p>
          <a:p>
            <a:pPr algn="just">
              <a:lnSpc>
                <a:spcPct val="150000"/>
              </a:lnSpc>
            </a:pPr>
            <a:endParaRPr lang="zh-CN" altLang="en-US" sz="1200" dirty="0">
              <a:solidFill>
                <a:srgbClr val="FF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" name="图片 3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8381"/>
            <a:ext cx="5695746" cy="683117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25689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Data 1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299782" y="476672"/>
            <a:ext cx="4896544" cy="39586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" name="TextBox 3"/>
          <p:cNvSpPr txBox="1"/>
          <p:nvPr/>
        </p:nvSpPr>
        <p:spPr>
          <a:xfrm>
            <a:off x="848544" y="5157192"/>
            <a:ext cx="7776864" cy="9694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5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solation of HA-immunoprecipitation proteins by SDS-PAGE.</a:t>
            </a:r>
            <a:r>
              <a:rPr lang="en-US" altLang="zh-CN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</a:p>
          <a:p>
            <a:pPr algn="just">
              <a:lnSpc>
                <a:spcPct val="150000"/>
              </a:lnSpc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ifferential bands are marked with arrows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Differential bands marked in red boxes were cut. Boxes 1, 3, 5, 7, and 9 were collected as the control group, and boxes 2, 4, 6, 8, and 10 were collected as the experimental group.</a:t>
            </a:r>
            <a:endParaRPr lang="zh-CN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437682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3"/>
          <p:cNvSpPr txBox="1"/>
          <p:nvPr/>
        </p:nvSpPr>
        <p:spPr>
          <a:xfrm>
            <a:off x="0" y="5872874"/>
            <a:ext cx="9906000" cy="9694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</a:t>
            </a:r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6. </a:t>
            </a:r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ignificantly enriched GO terms and enriched KEGG pathways.</a:t>
            </a:r>
          </a:p>
          <a:p>
            <a:pPr algn="just">
              <a:lnSpc>
                <a:spcPct val="150000"/>
              </a:lnSpc>
            </a:pP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The horizontal coordinate is the GO classification. The percent of genes is on the left side of the vertical coordinate and the number of genes is on the right side. (</a:t>
            </a:r>
            <a:r>
              <a:rPr lang="en-US" altLang="zh-CN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zh-CN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Enriched KEGG pathways. </a:t>
            </a:r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0512" y="-171400"/>
            <a:ext cx="8640960" cy="4402440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8504" y="3122923"/>
            <a:ext cx="8352928" cy="2970373"/>
          </a:xfrm>
          <a:prstGeom prst="rect">
            <a:avLst/>
          </a:prstGeom>
        </p:spPr>
      </p:pic>
      <p:sp>
        <p:nvSpPr>
          <p:cNvPr id="7" name="文本框 6"/>
          <p:cNvSpPr txBox="1"/>
          <p:nvPr/>
        </p:nvSpPr>
        <p:spPr>
          <a:xfrm>
            <a:off x="380492" y="116632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zh-CN" altLang="en-US" sz="14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80492" y="3467140"/>
            <a:ext cx="36004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zh-CN" altLang="en-U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995420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26</TotalTime>
  <Words>851</Words>
  <Application>Microsoft Office PowerPoint</Application>
  <PresentationFormat>A4 Paper (210x297 mm)</PresentationFormat>
  <Paragraphs>15</Paragraphs>
  <Slides>6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宋体</vt:lpstr>
      <vt:lpstr>Arial</vt:lpstr>
      <vt:lpstr>Calibri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loria</dc:creator>
  <cp:lastModifiedBy>MDPI</cp:lastModifiedBy>
  <cp:revision>73</cp:revision>
  <dcterms:created xsi:type="dcterms:W3CDTF">2020-09-28T12:16:45Z</dcterms:created>
  <dcterms:modified xsi:type="dcterms:W3CDTF">2021-09-06T05:41:06Z</dcterms:modified>
</cp:coreProperties>
</file>